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2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5" r:id="rId10"/>
    <p:sldId id="267" r:id="rId11"/>
    <p:sldId id="268" r:id="rId12"/>
    <p:sldId id="266" r:id="rId13"/>
    <p:sldId id="269" r:id="rId14"/>
    <p:sldId id="264" r:id="rId15"/>
    <p:sldId id="270" r:id="rId16"/>
    <p:sldId id="271" r:id="rId1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733049A-1BA4-4337-AF1A-2CE3125E9603}" v="17" dt="2020-10-15T17:20:10.77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3" d="100"/>
          <a:sy n="113" d="100"/>
        </p:scale>
        <p:origin x="1464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microsoft.com/office/2015/10/relationships/revisionInfo" Target="revisionInfo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athan Maren" userId="4ba76fdea76519be" providerId="Windows Live" clId="Web-{A733049A-1BA4-4337-AF1A-2CE3125E9603}"/>
    <pc:docChg chg="delSld modSld">
      <pc:chgData name="Nathan Maren" userId="4ba76fdea76519be" providerId="Windows Live" clId="Web-{A733049A-1BA4-4337-AF1A-2CE3125E9603}" dt="2020-10-15T17:20:10.777" v="16" actId="14100"/>
      <pc:docMkLst>
        <pc:docMk/>
      </pc:docMkLst>
      <pc:sldChg chg="del">
        <pc:chgData name="Nathan Maren" userId="4ba76fdea76519be" providerId="Windows Live" clId="Web-{A733049A-1BA4-4337-AF1A-2CE3125E9603}" dt="2020-10-15T17:07:13.243" v="0"/>
        <pc:sldMkLst>
          <pc:docMk/>
          <pc:sldMk cId="3439533220" sldId="256"/>
        </pc:sldMkLst>
      </pc:sldChg>
      <pc:sldChg chg="modSp">
        <pc:chgData name="Nathan Maren" userId="4ba76fdea76519be" providerId="Windows Live" clId="Web-{A733049A-1BA4-4337-AF1A-2CE3125E9603}" dt="2020-10-15T17:20:10.777" v="16" actId="14100"/>
        <pc:sldMkLst>
          <pc:docMk/>
          <pc:sldMk cId="3256597968" sldId="261"/>
        </pc:sldMkLst>
        <pc:picChg chg="mod">
          <ac:chgData name="Nathan Maren" userId="4ba76fdea76519be" providerId="Windows Live" clId="Web-{A733049A-1BA4-4337-AF1A-2CE3125E9603}" dt="2020-10-15T17:20:10.777" v="16" actId="14100"/>
          <ac:picMkLst>
            <pc:docMk/>
            <pc:sldMk cId="3256597968" sldId="261"/>
            <ac:picMk id="2" creationId="{00000000-0000-0000-0000-000000000000}"/>
          </ac:picMkLst>
        </pc:picChg>
      </pc:sldChg>
      <pc:sldChg chg="modSp">
        <pc:chgData name="Nathan Maren" userId="4ba76fdea76519be" providerId="Windows Live" clId="Web-{A733049A-1BA4-4337-AF1A-2CE3125E9603}" dt="2020-10-15T17:19:58.089" v="14" actId="14100"/>
        <pc:sldMkLst>
          <pc:docMk/>
          <pc:sldMk cId="261159907" sldId="262"/>
        </pc:sldMkLst>
        <pc:picChg chg="mod">
          <ac:chgData name="Nathan Maren" userId="4ba76fdea76519be" providerId="Windows Live" clId="Web-{A733049A-1BA4-4337-AF1A-2CE3125E9603}" dt="2020-10-15T17:19:58.089" v="14" actId="14100"/>
          <ac:picMkLst>
            <pc:docMk/>
            <pc:sldMk cId="261159907" sldId="262"/>
            <ac:picMk id="2" creationId="{00000000-0000-0000-0000-000000000000}"/>
          </ac:picMkLst>
        </pc:picChg>
      </pc:sldChg>
      <pc:sldChg chg="modSp">
        <pc:chgData name="Nathan Maren" userId="4ba76fdea76519be" providerId="Windows Live" clId="Web-{A733049A-1BA4-4337-AF1A-2CE3125E9603}" dt="2020-10-15T17:19:43.386" v="12" actId="14100"/>
        <pc:sldMkLst>
          <pc:docMk/>
          <pc:sldMk cId="4004853439" sldId="265"/>
        </pc:sldMkLst>
        <pc:picChg chg="mod">
          <ac:chgData name="Nathan Maren" userId="4ba76fdea76519be" providerId="Windows Live" clId="Web-{A733049A-1BA4-4337-AF1A-2CE3125E9603}" dt="2020-10-15T17:19:43.386" v="12" actId="14100"/>
          <ac:picMkLst>
            <pc:docMk/>
            <pc:sldMk cId="4004853439" sldId="265"/>
            <ac:picMk id="2" creationId="{00000000-0000-0000-0000-000000000000}"/>
          </ac:picMkLst>
        </pc:picChg>
      </pc:sldChg>
      <pc:sldChg chg="modSp">
        <pc:chgData name="Nathan Maren" userId="4ba76fdea76519be" providerId="Windows Live" clId="Web-{A733049A-1BA4-4337-AF1A-2CE3125E9603}" dt="2020-10-15T17:19:00.525" v="6" actId="14100"/>
        <pc:sldMkLst>
          <pc:docMk/>
          <pc:sldMk cId="911399189" sldId="266"/>
        </pc:sldMkLst>
        <pc:picChg chg="mod">
          <ac:chgData name="Nathan Maren" userId="4ba76fdea76519be" providerId="Windows Live" clId="Web-{A733049A-1BA4-4337-AF1A-2CE3125E9603}" dt="2020-10-15T17:19:00.525" v="6" actId="14100"/>
          <ac:picMkLst>
            <pc:docMk/>
            <pc:sldMk cId="911399189" sldId="266"/>
            <ac:picMk id="2" creationId="{00000000-0000-0000-0000-000000000000}"/>
          </ac:picMkLst>
        </pc:picChg>
      </pc:sldChg>
      <pc:sldChg chg="modSp">
        <pc:chgData name="Nathan Maren" userId="4ba76fdea76519be" providerId="Windows Live" clId="Web-{A733049A-1BA4-4337-AF1A-2CE3125E9603}" dt="2020-10-15T17:19:30.229" v="10" actId="14100"/>
        <pc:sldMkLst>
          <pc:docMk/>
          <pc:sldMk cId="4027036356" sldId="267"/>
        </pc:sldMkLst>
        <pc:picChg chg="mod">
          <ac:chgData name="Nathan Maren" userId="4ba76fdea76519be" providerId="Windows Live" clId="Web-{A733049A-1BA4-4337-AF1A-2CE3125E9603}" dt="2020-10-15T17:19:30.229" v="10" actId="14100"/>
          <ac:picMkLst>
            <pc:docMk/>
            <pc:sldMk cId="4027036356" sldId="267"/>
            <ac:picMk id="3" creationId="{00000000-0000-0000-0000-000000000000}"/>
          </ac:picMkLst>
        </pc:picChg>
      </pc:sldChg>
      <pc:sldChg chg="modSp">
        <pc:chgData name="Nathan Maren" userId="4ba76fdea76519be" providerId="Windows Live" clId="Web-{A733049A-1BA4-4337-AF1A-2CE3125E9603}" dt="2020-10-15T17:18:43.978" v="4" actId="14100"/>
        <pc:sldMkLst>
          <pc:docMk/>
          <pc:sldMk cId="780715043" sldId="268"/>
        </pc:sldMkLst>
        <pc:picChg chg="mod">
          <ac:chgData name="Nathan Maren" userId="4ba76fdea76519be" providerId="Windows Live" clId="Web-{A733049A-1BA4-4337-AF1A-2CE3125E9603}" dt="2020-10-15T17:18:43.978" v="4" actId="14100"/>
          <ac:picMkLst>
            <pc:docMk/>
            <pc:sldMk cId="780715043" sldId="268"/>
            <ac:picMk id="2" creationId="{00000000-0000-0000-0000-000000000000}"/>
          </ac:picMkLst>
        </pc:picChg>
      </pc:sldChg>
      <pc:sldChg chg="modSp">
        <pc:chgData name="Nathan Maren" userId="4ba76fdea76519be" providerId="Windows Live" clId="Web-{A733049A-1BA4-4337-AF1A-2CE3125E9603}" dt="2020-10-15T17:19:15.526" v="8" actId="14100"/>
        <pc:sldMkLst>
          <pc:docMk/>
          <pc:sldMk cId="1333471862" sldId="269"/>
        </pc:sldMkLst>
        <pc:picChg chg="mod">
          <ac:chgData name="Nathan Maren" userId="4ba76fdea76519be" providerId="Windows Live" clId="Web-{A733049A-1BA4-4337-AF1A-2CE3125E9603}" dt="2020-10-15T17:19:15.526" v="8" actId="14100"/>
          <ac:picMkLst>
            <pc:docMk/>
            <pc:sldMk cId="1333471862" sldId="269"/>
            <ac:picMk id="4" creationId="{00000000-0000-0000-0000-000000000000}"/>
          </ac:picMkLst>
        </pc:picChg>
      </pc:sldChg>
      <pc:sldChg chg="modSp">
        <pc:chgData name="Nathan Maren" userId="4ba76fdea76519be" providerId="Windows Live" clId="Web-{A733049A-1BA4-4337-AF1A-2CE3125E9603}" dt="2020-10-15T17:18:22.931" v="2" actId="14100"/>
        <pc:sldMkLst>
          <pc:docMk/>
          <pc:sldMk cId="3397489295" sldId="271"/>
        </pc:sldMkLst>
        <pc:picChg chg="mod">
          <ac:chgData name="Nathan Maren" userId="4ba76fdea76519be" providerId="Windows Live" clId="Web-{A733049A-1BA4-4337-AF1A-2CE3125E9603}" dt="2020-10-15T17:18:22.931" v="2" actId="14100"/>
          <ac:picMkLst>
            <pc:docMk/>
            <pc:sldMk cId="3397489295" sldId="271"/>
            <ac:picMk id="2" creationId="{00000000-0000-0000-0000-000000000000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202B0-F80C-47E5-8259-D78A82BCDD4B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29B7B-6520-4122-A778-32B21923D7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7861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202B0-F80C-47E5-8259-D78A82BCDD4B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29B7B-6520-4122-A778-32B21923D7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95890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202B0-F80C-47E5-8259-D78A82BCDD4B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29B7B-6520-4122-A778-32B21923D7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54453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202B0-F80C-47E5-8259-D78A82BCDD4B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29B7B-6520-4122-A778-32B21923D7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6192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202B0-F80C-47E5-8259-D78A82BCDD4B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29B7B-6520-4122-A778-32B21923D7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48526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202B0-F80C-47E5-8259-D78A82BCDD4B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29B7B-6520-4122-A778-32B21923D7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048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202B0-F80C-47E5-8259-D78A82BCDD4B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29B7B-6520-4122-A778-32B21923D7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28239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202B0-F80C-47E5-8259-D78A82BCDD4B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29B7B-6520-4122-A778-32B21923D7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20015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202B0-F80C-47E5-8259-D78A82BCDD4B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29B7B-6520-4122-A778-32B21923D7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7526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202B0-F80C-47E5-8259-D78A82BCDD4B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29B7B-6520-4122-A778-32B21923D7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42005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3202B0-F80C-47E5-8259-D78A82BCDD4B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229B7B-6520-4122-A778-32B21923D7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9514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3202B0-F80C-47E5-8259-D78A82BCDD4B}" type="datetimeFigureOut">
              <a:rPr lang="en-US" smtClean="0"/>
              <a:t>3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229B7B-6520-4122-A778-32B21923D7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24133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7725" y="366712"/>
            <a:ext cx="7448550" cy="6124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521871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2931" y="1050678"/>
            <a:ext cx="9149862" cy="47566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703635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2931" y="1059471"/>
            <a:ext cx="9149862" cy="47390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071504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2931" y="1059471"/>
            <a:ext cx="9149862" cy="47566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1139918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2931" y="1059471"/>
            <a:ext cx="9149862" cy="47390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347186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524000" y="1625697"/>
            <a:ext cx="12192000" cy="36066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2163631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192625"/>
            <a:ext cx="9144000" cy="27049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6827776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2931" y="2522511"/>
            <a:ext cx="9149862" cy="27097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974892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288" y="1509713"/>
            <a:ext cx="6829425" cy="3838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03505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288" y="1509713"/>
            <a:ext cx="6829425" cy="3838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921575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288" y="1509713"/>
            <a:ext cx="6829425" cy="3838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372189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288" y="1509713"/>
            <a:ext cx="6829425" cy="3838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7035592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3296" y="867875"/>
            <a:ext cx="9150593" cy="51222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5659796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3296" y="867875"/>
            <a:ext cx="9150593" cy="51398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115990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59242"/>
            <a:ext cx="9144000" cy="51395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2801577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2931" y="2074104"/>
            <a:ext cx="9149862" cy="27097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048534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</TotalTime>
  <Words>0</Words>
  <Application>Microsoft Office PowerPoint</Application>
  <PresentationFormat>On-screen Show (4:3)</PresentationFormat>
  <Paragraphs>0</Paragraphs>
  <Slides>1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2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than Maren</dc:creator>
  <cp:lastModifiedBy>Nathan Maren</cp:lastModifiedBy>
  <cp:revision>20</cp:revision>
  <dcterms:created xsi:type="dcterms:W3CDTF">2020-08-22T21:02:12Z</dcterms:created>
  <dcterms:modified xsi:type="dcterms:W3CDTF">2021-03-23T14:11:26Z</dcterms:modified>
</cp:coreProperties>
</file>